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>
      <p:cViewPr varScale="1">
        <p:scale>
          <a:sx n="127" d="100"/>
          <a:sy n="127" d="100"/>
        </p:scale>
        <p:origin x="5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D84BDB-EB74-6B94-AD6B-2844659135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08BCCCD-2124-C407-3302-2C30C64B37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EFABD9-B517-0B88-95A8-0229F30705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524791-D303-53E9-C7A5-AFD9D295C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261A71-C38A-59FD-0B2E-BBAA3569F3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008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53E4E-782E-BD30-6C63-B75EC186D2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E59697-F74C-7292-FA89-379F9CB8C5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4C4BDF-C7D7-24FC-5476-C39A1680B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928C3F-039D-3411-3195-B2F153896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AFE27B-0E62-5D1B-C7C5-787FB9B3E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959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570C613-94DC-3EDC-E8A0-486CBCE6EE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F26429-41AD-B54C-051E-A26691402A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4D3B0F-D9C7-F24D-A7A5-4184AA75A6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A77921-73A5-C3E8-92E1-B658117394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B1212E-4622-AD25-11EA-9B3DCA914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473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AD943A-75FA-2984-1048-9EA9FE4C3F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860797-E6F3-B7C5-2458-F30D686B48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45C441-4AB5-A421-3494-5D1542707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93255F-6514-D8E4-D56A-E5DA75997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E270AB-B50C-96AA-7F6B-F06EE5EB7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55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93674B-EF1D-18BE-9D14-D90717B40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5A5E53-4716-A1D8-ED55-4BF471F6DE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A48573-461C-AEC4-3EDE-8C4854713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B6AD81-C937-D2E1-18F9-CB67CD4B8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AABAB2-CBFB-1328-324C-AF5653C9B8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149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C015F3-B946-6919-CC75-97BD19147B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9E6212-1AB8-26A4-2359-B052DE784D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BA0BEF-6E70-9BB1-5BB6-A1E425C482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F4845C-1D74-9CC5-F068-321FA44914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660DE4-6D9C-6A60-0E21-0A294FD7F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BD68AE-3236-4B42-00DC-B10356937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003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029EF0-8E00-32F1-B834-7231929D9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16B6BE-AFC5-C955-A992-8275F76BD3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CFDFA3-6C57-9C33-A219-F94E9DCF26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7EAF0E-6E1B-0D3A-5416-EBC6718816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F9264C1-F468-7191-0145-CFD9096EFFD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C6FD49-DB9A-EC47-2546-5A78E1E43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20D09CF-FC6C-881E-9DF1-663315BA94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55E9A5-5E68-F850-C805-73FCEF92A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332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3016B-6E8C-6AF7-0C96-D4C1C8913B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67B8D9C-7C63-0EAC-AA46-77573AB7A1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C1FC55-A971-E43A-5B6C-9C884A711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1B23FF-C841-6581-F544-44F63CCBB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35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B5CEDD-6FB7-2811-4B3E-C78ADD839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B108D65-DA45-BCB9-07A9-0051C7BAF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79274E3-C59F-35AD-0251-5E673275A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207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81A67-970A-2AE6-7012-87C4838C05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AF28E1-C86A-9152-A7B6-1864153D57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4269A3-0EC4-E41B-377B-E342180E0A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364413-2478-17C8-AD88-25E31A8AB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778A90-1943-6C36-ED36-98BE2E725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C4B9E4-9733-FB37-1EC9-98FEAA44B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973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15FCD4-3439-6B5B-30B7-032B3F08A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037DE3D-7790-9A71-0C87-F51758A79F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622A1D-44E2-F3B7-2037-2AA8031FB1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474B95-CD69-F646-6599-72DD2621F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6D1F84-F502-7A44-F5D4-BBCC99A32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C696C4-62BC-0E2E-1CEA-BF4C40AC0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802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2154CA1-087B-C654-2296-DF39F2EE85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BE56E2-9A27-BA30-F335-398E1DB59E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7E2331-2266-5758-0B43-1C76B24A80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F2FAE1-358B-814F-8F44-5A8A24CFF0F2}" type="datetimeFigureOut">
              <a:rPr lang="en-US" smtClean="0"/>
              <a:t>9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AC6C90-E35C-5151-1F96-114BAC834D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816560-6B7A-B03E-6E61-F227CF65E3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EB077E-D9B0-6C4D-9493-3762635386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985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Multimedia2">
            <a:hlinkClick r:id="" action="ppaction://media"/>
            <a:extLst>
              <a:ext uri="{FF2B5EF4-FFF2-40B4-BE49-F238E27FC236}">
                <a16:creationId xmlns:a16="http://schemas.microsoft.com/office/drawing/2014/main" id="{860F05D1-7873-029C-DC18-634140E4423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7333298" y="0"/>
            <a:ext cx="3857625" cy="6858000"/>
          </a:xfrm>
          <a:prstGeom prst="rect">
            <a:avLst/>
          </a:prstGeom>
        </p:spPr>
      </p:pic>
      <p:pic>
        <p:nvPicPr>
          <p:cNvPr id="3" name="Multimedia1">
            <a:hlinkClick r:id="" action="ppaction://media"/>
            <a:extLst>
              <a:ext uri="{FF2B5EF4-FFF2-40B4-BE49-F238E27FC236}">
                <a16:creationId xmlns:a16="http://schemas.microsoft.com/office/drawing/2014/main" id="{595F9AD2-D37F-A13F-68A5-8808327C9263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0" y="0"/>
            <a:ext cx="3857625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630BA34-7A03-79F7-2EE5-FA30BEFF19B5}"/>
              </a:ext>
            </a:extLst>
          </p:cNvPr>
          <p:cNvSpPr txBox="1"/>
          <p:nvPr/>
        </p:nvSpPr>
        <p:spPr>
          <a:xfrm>
            <a:off x="35877" y="227092"/>
            <a:ext cx="2094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tandard chow diet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E271BAE-9E5B-586C-A0F1-3B827E463BCD}"/>
              </a:ext>
            </a:extLst>
          </p:cNvPr>
          <p:cNvSpPr txBox="1"/>
          <p:nvPr/>
        </p:nvSpPr>
        <p:spPr>
          <a:xfrm>
            <a:off x="9144000" y="213360"/>
            <a:ext cx="1846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KD + MBZ + DON </a:t>
            </a:r>
          </a:p>
        </p:txBody>
      </p:sp>
    </p:spTree>
    <p:extLst>
      <p:ext uri="{BB962C8B-B14F-4D97-AF65-F5344CB8AC3E}">
        <p14:creationId xmlns:p14="http://schemas.microsoft.com/office/powerpoint/2010/main" val="25101167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9208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8624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6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EEB166C-6184-A0FC-CC0C-1EDA7916764A}"/>
              </a:ext>
            </a:extLst>
          </p:cNvPr>
          <p:cNvSpPr txBox="1"/>
          <p:nvPr/>
        </p:nvSpPr>
        <p:spPr>
          <a:xfrm>
            <a:off x="396240" y="1206421"/>
            <a:ext cx="11419840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figure 2b video –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rapeutic effect of MBZ and DON used in combination with the KD on the orthotopic growth of VM-M3/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c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lioblastoma cells in syngeneic p21-25 VM/Dk mice.   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M-M3/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r cells were implanted as described in methods.  The mice in the video are shown at 18 days after tumor implantation and 10 days after initiation of the diet/drug therapy (KD + MBZ + DON).  The treated mice were ambulatory and appeared healthy in contrast to the mice fed the control high-carbohydrate SD that were sedentary and appeared moribund (described in the text). </a:t>
            </a:r>
          </a:p>
        </p:txBody>
      </p:sp>
    </p:spTree>
    <p:extLst>
      <p:ext uri="{BB962C8B-B14F-4D97-AF65-F5344CB8AC3E}">
        <p14:creationId xmlns:p14="http://schemas.microsoft.com/office/powerpoint/2010/main" val="4188862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16</Words>
  <Application>Microsoft Macintosh PowerPoint</Application>
  <PresentationFormat>Widescreen</PresentationFormat>
  <Paragraphs>5</Paragraphs>
  <Slides>2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Purna Mukherjee</cp:lastModifiedBy>
  <cp:revision>8</cp:revision>
  <dcterms:created xsi:type="dcterms:W3CDTF">2024-09-23T18:12:45Z</dcterms:created>
  <dcterms:modified xsi:type="dcterms:W3CDTF">2025-09-11T17:44:23Z</dcterms:modified>
  <cp:category/>
</cp:coreProperties>
</file>